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  <p:sldId id="259" r:id="rId3"/>
    <p:sldId id="256" r:id="rId4"/>
    <p:sldId id="258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3887"/>
    <p:restoredTop sz="94729"/>
  </p:normalViewPr>
  <p:slideViewPr>
    <p:cSldViewPr snapToGrid="0">
      <p:cViewPr varScale="1">
        <p:scale>
          <a:sx n="104" d="100"/>
          <a:sy n="104" d="100"/>
        </p:scale>
        <p:origin x="116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D242B-CCD3-6C43-9C9D-BF35B0A0E8EA}" type="datetimeFigureOut">
              <a:rPr kumimoji="1" lang="ja-JP" altLang="en-US" smtClean="0"/>
              <a:t>2025/7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4F661-FAAD-A045-8D94-A88C64B065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85981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D242B-CCD3-6C43-9C9D-BF35B0A0E8EA}" type="datetimeFigureOut">
              <a:rPr kumimoji="1" lang="ja-JP" altLang="en-US" smtClean="0"/>
              <a:t>2025/7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4F661-FAAD-A045-8D94-A88C64B065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4375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D242B-CCD3-6C43-9C9D-BF35B0A0E8EA}" type="datetimeFigureOut">
              <a:rPr kumimoji="1" lang="ja-JP" altLang="en-US" smtClean="0"/>
              <a:t>2025/7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4F661-FAAD-A045-8D94-A88C64B065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71221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D242B-CCD3-6C43-9C9D-BF35B0A0E8EA}" type="datetimeFigureOut">
              <a:rPr kumimoji="1" lang="ja-JP" altLang="en-US" smtClean="0"/>
              <a:t>2025/7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4F661-FAAD-A045-8D94-A88C64B065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77299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D242B-CCD3-6C43-9C9D-BF35B0A0E8EA}" type="datetimeFigureOut">
              <a:rPr kumimoji="1" lang="ja-JP" altLang="en-US" smtClean="0"/>
              <a:t>2025/7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4F661-FAAD-A045-8D94-A88C64B065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82977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D242B-CCD3-6C43-9C9D-BF35B0A0E8EA}" type="datetimeFigureOut">
              <a:rPr kumimoji="1" lang="ja-JP" altLang="en-US" smtClean="0"/>
              <a:t>2025/7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4F661-FAAD-A045-8D94-A88C64B065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42325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D242B-CCD3-6C43-9C9D-BF35B0A0E8EA}" type="datetimeFigureOut">
              <a:rPr kumimoji="1" lang="ja-JP" altLang="en-US" smtClean="0"/>
              <a:t>2025/7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4F661-FAAD-A045-8D94-A88C64B065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98707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D242B-CCD3-6C43-9C9D-BF35B0A0E8EA}" type="datetimeFigureOut">
              <a:rPr kumimoji="1" lang="ja-JP" altLang="en-US" smtClean="0"/>
              <a:t>2025/7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4F661-FAAD-A045-8D94-A88C64B065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1698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D242B-CCD3-6C43-9C9D-BF35B0A0E8EA}" type="datetimeFigureOut">
              <a:rPr kumimoji="1" lang="ja-JP" altLang="en-US" smtClean="0"/>
              <a:t>2025/7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4F661-FAAD-A045-8D94-A88C64B065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0924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D242B-CCD3-6C43-9C9D-BF35B0A0E8EA}" type="datetimeFigureOut">
              <a:rPr kumimoji="1" lang="ja-JP" altLang="en-US" smtClean="0"/>
              <a:t>2025/7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4F661-FAAD-A045-8D94-A88C64B065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89757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D242B-CCD3-6C43-9C9D-BF35B0A0E8EA}" type="datetimeFigureOut">
              <a:rPr kumimoji="1" lang="ja-JP" altLang="en-US" smtClean="0"/>
              <a:t>2025/7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4F661-FAAD-A045-8D94-A88C64B065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5591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DD242B-CCD3-6C43-9C9D-BF35B0A0E8EA}" type="datetimeFigureOut">
              <a:rPr kumimoji="1" lang="ja-JP" altLang="en-US" smtClean="0"/>
              <a:t>2025/7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F4F661-FAAD-A045-8D94-A88C64B065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37280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9FB75A8-6DE2-A659-D171-98B7B88C52B8}"/>
              </a:ext>
            </a:extLst>
          </p:cNvPr>
          <p:cNvSpPr txBox="1"/>
          <p:nvPr/>
        </p:nvSpPr>
        <p:spPr>
          <a:xfrm>
            <a:off x="360276" y="4547618"/>
            <a:ext cx="8423448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1600" b="1" dirty="0">
                <a:solidFill>
                  <a:srgbClr val="000000"/>
                </a:solidFill>
                <a:latin typeface="Palatino Linotype" panose="02040502050505030304" pitchFamily="18" charset="0"/>
              </a:rPr>
              <a:t>Figure S1</a:t>
            </a:r>
            <a:r>
              <a:rPr lang="ja-JP" altLang="en-US" sz="1600" b="1">
                <a:solidFill>
                  <a:srgbClr val="000000"/>
                </a:solidFill>
                <a:latin typeface="Palatino Linotype" panose="02040502050505030304" pitchFamily="18" charset="0"/>
              </a:rPr>
              <a:t>：</a:t>
            </a:r>
            <a:r>
              <a:rPr lang="en" altLang="ja-JP" sz="1600" b="1" dirty="0">
                <a:solidFill>
                  <a:srgbClr val="000000"/>
                </a:solidFill>
                <a:latin typeface="Palatino Linotype" panose="02040502050505030304" pitchFamily="18" charset="0"/>
              </a:rPr>
              <a:t> </a:t>
            </a:r>
            <a:r>
              <a:rPr lang="en" altLang="ja-JP" sz="16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</a:rPr>
              <a:t>Flowchart of IOTN Classification and Orthodontic Treatment Need Categories.</a:t>
            </a:r>
          </a:p>
          <a:p>
            <a:endParaRPr lang="en" altLang="ja-JP" sz="1600" dirty="0">
              <a:solidFill>
                <a:srgbClr val="000000"/>
              </a:solidFill>
              <a:latin typeface="Palatino Linotype" panose="02040502050505030304" pitchFamily="18" charset="0"/>
            </a:endParaRPr>
          </a:p>
          <a:p>
            <a:r>
              <a:rPr lang="en" altLang="ja-JP" sz="1600" dirty="0">
                <a:solidFill>
                  <a:srgbClr val="000000"/>
                </a:solidFill>
                <a:latin typeface="Palatino Linotype" panose="02040502050505030304" pitchFamily="18" charset="0"/>
              </a:rPr>
              <a:t>Illustrates the classification of orthodontic treatment need based on IOTN-DHC and AC scores. </a:t>
            </a:r>
          </a:p>
          <a:p>
            <a:r>
              <a:rPr lang="en" altLang="ja-JP" sz="1600" dirty="0">
                <a:solidFill>
                  <a:srgbClr val="000000"/>
                </a:solidFill>
                <a:latin typeface="Palatino Linotype" panose="02040502050505030304" pitchFamily="18" charset="0"/>
              </a:rPr>
              <a:t>DHC grades were categorized into three treatment need levels according to Richmond’s criteria: grades 1–2 indicated no treatment need, grade 3 represented borderline need, and grades 4–5 indicated definite treatment need. Similarly, AC scores of 1–4 represented no need, 5–7 were borderline, and 8–10 indicated treatment required.</a:t>
            </a:r>
            <a:endParaRPr lang="ja-JP" altLang="en-US" sz="1600">
              <a:latin typeface="Palatino Linotype" panose="0204050205050503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FE9C24D9-1124-2D9B-F962-E5C9702765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800" y="657255"/>
            <a:ext cx="7772400" cy="32334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1384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046C6034-4C8F-6D99-23EF-4EFB116611B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54760822"/>
              </p:ext>
            </p:extLst>
          </p:nvPr>
        </p:nvGraphicFramePr>
        <p:xfrm>
          <a:off x="3187389" y="742036"/>
          <a:ext cx="2769215" cy="44853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921901">
                  <a:extLst>
                    <a:ext uri="{9D8B030D-6E8A-4147-A177-3AD203B41FA5}">
                      <a16:colId xmlns:a16="http://schemas.microsoft.com/office/drawing/2014/main" val="376085579"/>
                    </a:ext>
                  </a:extLst>
                </a:gridCol>
                <a:gridCol w="711238">
                  <a:extLst>
                    <a:ext uri="{9D8B030D-6E8A-4147-A177-3AD203B41FA5}">
                      <a16:colId xmlns:a16="http://schemas.microsoft.com/office/drawing/2014/main" val="3783210830"/>
                    </a:ext>
                  </a:extLst>
                </a:gridCol>
                <a:gridCol w="1136076">
                  <a:extLst>
                    <a:ext uri="{9D8B030D-6E8A-4147-A177-3AD203B41FA5}">
                      <a16:colId xmlns:a16="http://schemas.microsoft.com/office/drawing/2014/main" val="3392953031"/>
                    </a:ext>
                  </a:extLst>
                </a:gridCol>
              </a:tblGrid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DHC Grade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Item Code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Number of Students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2520588559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5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i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8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3599366160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5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h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0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3495165235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5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a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3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3350547686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5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m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861664385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5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p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3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2699650121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5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s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2163752470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4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h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0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463283685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4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a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31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3098103089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4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b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88624184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4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m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3309898508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4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c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4071050521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4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I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0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388466208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4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d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111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1213985137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4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e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996301746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4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f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21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4160323268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4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x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105792415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3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a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38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396277427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3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b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3840206729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3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c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11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2644821525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3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d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307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928660542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3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e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6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3170428724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3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f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48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2510745927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a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219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2761352930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b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3805267700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c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36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1442699637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d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459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3667383592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e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20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3153159166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f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163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1346834776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g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219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1663132100"/>
                  </a:ext>
                </a:extLst>
              </a:tr>
              <a:tr h="140366"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effectLst/>
                          <a:latin typeface="Palatino Linotype" panose="02040502050505030304" pitchFamily="18" charset="0"/>
                        </a:rPr>
                        <a:t>726</a:t>
                      </a:r>
                      <a:endParaRPr lang="ja-JP" sz="9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141" marR="54141" marT="0" marB="0"/>
                </a:tc>
                <a:extLst>
                  <a:ext uri="{0D108BD9-81ED-4DB2-BD59-A6C34878D82A}">
                    <a16:rowId xmlns:a16="http://schemas.microsoft.com/office/drawing/2014/main" val="2276836614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7BE4FC6-182C-AE6A-1464-F18704FBFA33}"/>
              </a:ext>
            </a:extLst>
          </p:cNvPr>
          <p:cNvSpPr txBox="1"/>
          <p:nvPr/>
        </p:nvSpPr>
        <p:spPr>
          <a:xfrm>
            <a:off x="298207" y="5278715"/>
            <a:ext cx="854758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34" charset="-128"/>
                <a:cs typeface="Arial" panose="020B0604020202020204" pitchFamily="34" charset="0"/>
              </a:rPr>
              <a:t>Item codes correspond to specific malocclusion features: a: Increased overjet, b: Reverse overjet, c: Anterior or posterior crossbite, d: Crowding, e: Open bite, f: Increased overbite, g: Molar relationship, h: Cleft lip and/or palate, 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34" charset="-128"/>
                <a:cs typeface="Arial" panose="020B0604020202020204" pitchFamily="34" charset="0"/>
              </a:rPr>
              <a:t>i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34" charset="-128"/>
                <a:cs typeface="Arial" panose="020B0604020202020204" pitchFamily="34" charset="0"/>
              </a:rPr>
              <a:t>: Impeded eruption of teeth, m: Reverse overjet with functional problems, p: Craniofacial syndrome or cleft-related defects, s: Supernumerary teeth, t: Hypodontia, x: Other anomalies (e.g., displaced teeth), I: Impacted teeth, 1: No abnormal findings. Note: Code "1" indicates cases where no abnormal morphological findings were observed; this does not correspond to DHC grade 1, which may still include minor malocclusion.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One individual may present with multiple DHC items; therefore, the total number in the right column exceeds the number of participants. Cells with ‘0’ indicate that no participants in that DHC grade presented with the corresponding item.</a:t>
            </a:r>
            <a:endParaRPr kumimoji="1" lang="ja-JP" altLang="en-US" sz="120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BDC3A48-6C15-5C72-B54B-EF42BD8DC9EF}"/>
              </a:ext>
            </a:extLst>
          </p:cNvPr>
          <p:cNvSpPr txBox="1"/>
          <p:nvPr/>
        </p:nvSpPr>
        <p:spPr>
          <a:xfrm>
            <a:off x="101065" y="157813"/>
            <a:ext cx="894186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Table S1. 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Number of students who tested positive for each item in the Dental Health Component (DHC) of the Index of Orthodontic Treatment Need (IOTN), by DHC grade.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ＭＳ Ｐゴシック" panose="020B0600070205080204" pitchFamily="34" charset="-128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3014762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B28130F3-9252-F22B-3AE8-6323395C2EC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38489970"/>
              </p:ext>
            </p:extLst>
          </p:nvPr>
        </p:nvGraphicFramePr>
        <p:xfrm>
          <a:off x="1556475" y="1920240"/>
          <a:ext cx="6031047" cy="301752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051752">
                  <a:extLst>
                    <a:ext uri="{9D8B030D-6E8A-4147-A177-3AD203B41FA5}">
                      <a16:colId xmlns:a16="http://schemas.microsoft.com/office/drawing/2014/main" val="3055557950"/>
                    </a:ext>
                  </a:extLst>
                </a:gridCol>
                <a:gridCol w="2442520">
                  <a:extLst>
                    <a:ext uri="{9D8B030D-6E8A-4147-A177-3AD203B41FA5}">
                      <a16:colId xmlns:a16="http://schemas.microsoft.com/office/drawing/2014/main" val="767962436"/>
                    </a:ext>
                  </a:extLst>
                </a:gridCol>
                <a:gridCol w="1536775">
                  <a:extLst>
                    <a:ext uri="{9D8B030D-6E8A-4147-A177-3AD203B41FA5}">
                      <a16:colId xmlns:a16="http://schemas.microsoft.com/office/drawing/2014/main" val="133513376"/>
                    </a:ext>
                  </a:extLst>
                </a:gridCol>
              </a:tblGrid>
              <a:tr h="211138"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AC Grade Cutoff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Coefficient (95% CI)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P-value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4101000063"/>
                  </a:ext>
                </a:extLst>
              </a:tr>
              <a:tr h="211138"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0/1–10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-24.31 ( -33.64 – -14.98)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&lt;0.001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3136187303"/>
                  </a:ext>
                </a:extLst>
              </a:tr>
              <a:tr h="211138"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0–1/2–10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-19.06 ( -28.38 – -9.73)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&lt;0.001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2773543098"/>
                  </a:ext>
                </a:extLst>
              </a:tr>
              <a:tr h="211138"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0–2/3–10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-17.49 ( -26.81 – -8.18)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&lt;0.001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1315542135"/>
                  </a:ext>
                </a:extLst>
              </a:tr>
              <a:tr h="211138"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0–3/4–10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-16.11 ( -25.42 – -6.8)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0.001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1347977687"/>
                  </a:ext>
                </a:extLst>
              </a:tr>
              <a:tr h="211138"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0–4/5–10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-14.95 ( -24.24 – -5.66)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0.002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3319990276"/>
                  </a:ext>
                </a:extLst>
              </a:tr>
              <a:tr h="211138"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0–5/6–10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-14.36 ( -23.64 – -5.07)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0.002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3663986766"/>
                  </a:ext>
                </a:extLst>
              </a:tr>
              <a:tr h="211138"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0–6/7–10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-13.96 ( -23.24 – -4.69)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0.003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3232441893"/>
                  </a:ext>
                </a:extLst>
              </a:tr>
              <a:tr h="211138"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0–7/8–10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-13.29 ( -22.55 – -4.02)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0.005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4081570491"/>
                  </a:ext>
                </a:extLst>
              </a:tr>
              <a:tr h="211138"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0–8/9–10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-11.91 ( -21.14 – -2.68)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0.011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3368063402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/>
                      <a:r>
                        <a:rPr lang="en-US" sz="1800" dirty="0">
                          <a:effectLst/>
                          <a:latin typeface="Palatino Linotype" panose="02040502050505030304" pitchFamily="18" charset="0"/>
                        </a:rPr>
                        <a:t>0–9/10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>
                          <a:effectLst/>
                          <a:latin typeface="Palatino Linotype" panose="02040502050505030304" pitchFamily="18" charset="0"/>
                        </a:rPr>
                        <a:t>-11.02 ( -20.25 – -1.8)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>
                          <a:effectLst/>
                          <a:latin typeface="Palatino Linotype" panose="02040502050505030304" pitchFamily="18" charset="0"/>
                        </a:rPr>
                        <a:t>0.019</a:t>
                      </a:r>
                      <a:endParaRPr lang="ja-JP" sz="18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extLst>
                  <a:ext uri="{0D108BD9-81ED-4DB2-BD59-A6C34878D82A}">
                    <a16:rowId xmlns:a16="http://schemas.microsoft.com/office/drawing/2014/main" val="1203181595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BAF2F44-76AF-0420-D36C-15F9DE1CB8DA}"/>
              </a:ext>
            </a:extLst>
          </p:cNvPr>
          <p:cNvSpPr txBox="1"/>
          <p:nvPr/>
        </p:nvSpPr>
        <p:spPr>
          <a:xfrm>
            <a:off x="140114" y="282944"/>
            <a:ext cx="886376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b="1" dirty="0">
                <a:latin typeface="Palatino Linotype" panose="02040502050505030304" pitchFamily="18" charset="0"/>
              </a:rPr>
              <a:t>Table S2. </a:t>
            </a:r>
            <a:r>
              <a:rPr lang="en-US" altLang="ja-JP" sz="135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A) Results of cutoff-specific logistic regression analyses for Aesthetic Component (AC) grade thresholds predicting high orthodontic treatment need (DHC grade 4 or 5).</a:t>
            </a:r>
            <a:r>
              <a:rPr lang="en-US" altLang="ja-JP" sz="1350" dirty="0">
                <a:solidFill>
                  <a:srgbClr val="FF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ja-JP" sz="135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table presents model coefficients with 95% confidence intervals and P-values. More negative coefficients indicate stronger associations between higher AC grades and increased likelihood of clinical treatment need. While conceptually related to ROC analysis, these models do not involve AUC-based evaluation. </a:t>
            </a:r>
          </a:p>
        </p:txBody>
      </p:sp>
    </p:spTree>
    <p:extLst>
      <p:ext uri="{BB962C8B-B14F-4D97-AF65-F5344CB8AC3E}">
        <p14:creationId xmlns:p14="http://schemas.microsoft.com/office/powerpoint/2010/main" val="33297956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4273ACD5-9BE4-3D07-88FF-EBB5616480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11355540"/>
              </p:ext>
            </p:extLst>
          </p:nvPr>
        </p:nvGraphicFramePr>
        <p:xfrm>
          <a:off x="1771993" y="1168973"/>
          <a:ext cx="5600014" cy="554736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425214">
                  <a:extLst>
                    <a:ext uri="{9D8B030D-6E8A-4147-A177-3AD203B41FA5}">
                      <a16:colId xmlns:a16="http://schemas.microsoft.com/office/drawing/2014/main" val="2696099506"/>
                    </a:ext>
                  </a:extLst>
                </a:gridCol>
                <a:gridCol w="1191599">
                  <a:extLst>
                    <a:ext uri="{9D8B030D-6E8A-4147-A177-3AD203B41FA5}">
                      <a16:colId xmlns:a16="http://schemas.microsoft.com/office/drawing/2014/main" val="2764786050"/>
                    </a:ext>
                  </a:extLst>
                </a:gridCol>
                <a:gridCol w="2025215">
                  <a:extLst>
                    <a:ext uri="{9D8B030D-6E8A-4147-A177-3AD203B41FA5}">
                      <a16:colId xmlns:a16="http://schemas.microsoft.com/office/drawing/2014/main" val="1333044853"/>
                    </a:ext>
                  </a:extLst>
                </a:gridCol>
                <a:gridCol w="957986">
                  <a:extLst>
                    <a:ext uri="{9D8B030D-6E8A-4147-A177-3AD203B41FA5}">
                      <a16:colId xmlns:a16="http://schemas.microsoft.com/office/drawing/2014/main" val="3978941194"/>
                    </a:ext>
                  </a:extLst>
                </a:gridCol>
              </a:tblGrid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Grade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Item Code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Coefficient (95% CI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P-value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2496076177"/>
                  </a:ext>
                </a:extLst>
              </a:tr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5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i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-1.02 ( -2.28 – 0.23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109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1147635245"/>
                  </a:ext>
                </a:extLst>
              </a:tr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5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a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-1.27 ( -3.4 – 0.86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243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1460889315"/>
                  </a:ext>
                </a:extLst>
              </a:tr>
              <a:tr h="145057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5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m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-4.09 ( -7.57 – -0.61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021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3496689306"/>
                  </a:ext>
                </a:extLst>
              </a:tr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5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p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-2.19 ( -5.67 – 1.3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220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3182236975"/>
                  </a:ext>
                </a:extLst>
              </a:tr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5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s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5.63 ( -1.16 – 12.43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104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96314779"/>
                  </a:ext>
                </a:extLst>
              </a:tr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4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a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-0.53 ( -2.02 – 0.96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488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1163303917"/>
                  </a:ext>
                </a:extLst>
              </a:tr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4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b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-6.38 ( -10.03 – -2.74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001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335259310"/>
                  </a:ext>
                </a:extLst>
              </a:tr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4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m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06 ( -2.45 – 2.56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965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3378623089"/>
                  </a:ext>
                </a:extLst>
              </a:tr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4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c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-1.08 ( -3.83 – 1.66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439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891390293"/>
                  </a:ext>
                </a:extLst>
              </a:tr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4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-1.42 ( -1.86 – -0.98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000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2432230984"/>
                  </a:ext>
                </a:extLst>
              </a:tr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4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e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28 ( -2.81 – 3.38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858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3697593567"/>
                  </a:ext>
                </a:extLst>
              </a:tr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4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f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01 ( -1.03 – 1.04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988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1557070702"/>
                  </a:ext>
                </a:extLst>
              </a:tr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4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x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11 ( -4.85 – 5.07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966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4279181872"/>
                  </a:ext>
                </a:extLst>
              </a:tr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3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a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-0.11 ( -1.46 – 1.25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879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103226335"/>
                  </a:ext>
                </a:extLst>
              </a:tr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3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c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78 ( -0.62 – 2.19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273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873896283"/>
                  </a:ext>
                </a:extLst>
              </a:tr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3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-1.03 ( -1.43 – -0.63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000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2490012077"/>
                  </a:ext>
                </a:extLst>
              </a:tr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3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e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-0.3 ( -2.28 – 1.69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769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749670321"/>
                  </a:ext>
                </a:extLst>
              </a:tr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3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f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-0.72 ( -1.49 – 0.06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069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2217349191"/>
                  </a:ext>
                </a:extLst>
              </a:tr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2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a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-0.51 ( -0.85 – -0.18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003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4139696237"/>
                  </a:ext>
                </a:extLst>
              </a:tr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2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c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-1.19 ( -1.93 – -0.46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001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1297474005"/>
                  </a:ext>
                </a:extLst>
              </a:tr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2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-0.72 ( -1.1 – -0.35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&lt;0.001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1113984894"/>
                  </a:ext>
                </a:extLst>
              </a:tr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2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e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-2.16 ( -3.12 – -1.2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&lt;0.001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2552286505"/>
                  </a:ext>
                </a:extLst>
              </a:tr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2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f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-0.59 ( -0.99 – -0.2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0.003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4205202237"/>
                  </a:ext>
                </a:extLst>
              </a:tr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2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g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-0.93 ( -1.23 – -0.62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&lt;0.001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485730528"/>
                  </a:ext>
                </a:extLst>
              </a:tr>
              <a:tr h="149591"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DHC 1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  <a:latin typeface="Palatino Linotype" panose="02040502050505030304" pitchFamily="18" charset="0"/>
                        </a:rPr>
                        <a:t>—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-2.32 ( -8.09 – 3.45)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effectLst/>
                          <a:latin typeface="Palatino Linotype" panose="02040502050505030304" pitchFamily="18" charset="0"/>
                        </a:rPr>
                        <a:t>0.431</a:t>
                      </a:r>
                      <a:endParaRPr lang="ja-JP" sz="140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415" marR="48415" marT="0" marB="0"/>
                </a:tc>
                <a:extLst>
                  <a:ext uri="{0D108BD9-81ED-4DB2-BD59-A6C34878D82A}">
                    <a16:rowId xmlns:a16="http://schemas.microsoft.com/office/drawing/2014/main" val="986014698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BAF2F44-76AF-0420-D36C-15F9DE1CB8DA}"/>
              </a:ext>
            </a:extLst>
          </p:cNvPr>
          <p:cNvSpPr txBox="1"/>
          <p:nvPr/>
        </p:nvSpPr>
        <p:spPr>
          <a:xfrm>
            <a:off x="239183" y="37894"/>
            <a:ext cx="8665634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b="1" dirty="0">
                <a:latin typeface="Palatino Linotype" panose="02040502050505030304" pitchFamily="18" charset="0"/>
              </a:rPr>
              <a:t>Table S2. </a:t>
            </a:r>
            <a:r>
              <a:rPr lang="en-US" altLang="ja-JP" sz="1350" dirty="0">
                <a:solidFill>
                  <a:srgbClr val="000000"/>
                </a:solidFill>
                <a:latin typeface="Palatino Linotype" panose="0204050205050503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(B) Results of simple linear regression models assessing the association between individual DHC items and Aesthetic Component (AC) grade. Each DHC item was entered separately as a binary independent variable (present = 1, absent = 0), and AC grade was used as the dependent variable. Coefficients indicate the direction and magnitude of the effect on AC grade. Statistically significant predictors are highlighted in bold. </a:t>
            </a:r>
            <a:r>
              <a:rPr lang="en-US" altLang="ja-JP" sz="135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tem codes are consistent with those listed in Table 3 (e.g., a = increased overjet, d = crowding).</a:t>
            </a:r>
            <a:r>
              <a:rPr lang="ja-JP" altLang="ja-JP" sz="1350">
                <a:latin typeface="Palatino Linotype" panose="02040502050505030304" pitchFamily="18" charset="0"/>
              </a:rPr>
              <a:t> </a:t>
            </a:r>
            <a:endParaRPr lang="ja-JP" altLang="en-US" sz="135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85149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9</TotalTime>
  <Words>1017</Words>
  <Application>Microsoft Macintosh PowerPoint</Application>
  <PresentationFormat>画面に合わせる (4:3)</PresentationFormat>
  <Paragraphs>238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雄大 新保</dc:creator>
  <cp:lastModifiedBy>雄大 新保</cp:lastModifiedBy>
  <cp:revision>10</cp:revision>
  <dcterms:created xsi:type="dcterms:W3CDTF">2025-06-17T23:31:41Z</dcterms:created>
  <dcterms:modified xsi:type="dcterms:W3CDTF">2025-07-06T15:46:28Z</dcterms:modified>
</cp:coreProperties>
</file>